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85" r:id="rId2"/>
    <p:sldId id="262" r:id="rId3"/>
    <p:sldId id="279" r:id="rId4"/>
    <p:sldId id="283" r:id="rId5"/>
    <p:sldId id="286" r:id="rId6"/>
    <p:sldId id="284" r:id="rId7"/>
    <p:sldId id="277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440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A5A9BB-8029-4B07-A142-56959B87FAAD}" type="datetimeFigureOut">
              <a:rPr lang="en-GB" smtClean="0"/>
              <a:t>31/10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91A536-9E64-4910-888E-F976D02261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78267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B91A536-9E64-4910-888E-F976D022612B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16151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330B3-6EF5-4854-A183-447EC6329E64}" type="datetimeFigureOut">
              <a:rPr lang="en-GB" smtClean="0"/>
              <a:t>31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13F47-1120-48DE-90C6-AA833649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1335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330B3-6EF5-4854-A183-447EC6329E64}" type="datetimeFigureOut">
              <a:rPr lang="en-GB" smtClean="0"/>
              <a:t>31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13F47-1120-48DE-90C6-AA833649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5132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330B3-6EF5-4854-A183-447EC6329E64}" type="datetimeFigureOut">
              <a:rPr lang="en-GB" smtClean="0"/>
              <a:t>31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13F47-1120-48DE-90C6-AA833649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6926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330B3-6EF5-4854-A183-447EC6329E64}" type="datetimeFigureOut">
              <a:rPr lang="en-GB" smtClean="0"/>
              <a:t>31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13F47-1120-48DE-90C6-AA833649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9920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330B3-6EF5-4854-A183-447EC6329E64}" type="datetimeFigureOut">
              <a:rPr lang="en-GB" smtClean="0"/>
              <a:t>31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13F47-1120-48DE-90C6-AA833649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2939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330B3-6EF5-4854-A183-447EC6329E64}" type="datetimeFigureOut">
              <a:rPr lang="en-GB" smtClean="0"/>
              <a:t>31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13F47-1120-48DE-90C6-AA833649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1789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330B3-6EF5-4854-A183-447EC6329E64}" type="datetimeFigureOut">
              <a:rPr lang="en-GB" smtClean="0"/>
              <a:t>31/10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13F47-1120-48DE-90C6-AA833649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3020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330B3-6EF5-4854-A183-447EC6329E64}" type="datetimeFigureOut">
              <a:rPr lang="en-GB" smtClean="0"/>
              <a:t>31/10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13F47-1120-48DE-90C6-AA833649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7697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330B3-6EF5-4854-A183-447EC6329E64}" type="datetimeFigureOut">
              <a:rPr lang="en-GB" smtClean="0"/>
              <a:t>31/10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13F47-1120-48DE-90C6-AA833649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3523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330B3-6EF5-4854-A183-447EC6329E64}" type="datetimeFigureOut">
              <a:rPr lang="en-GB" smtClean="0"/>
              <a:t>31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13F47-1120-48DE-90C6-AA833649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409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330B3-6EF5-4854-A183-447EC6329E64}" type="datetimeFigureOut">
              <a:rPr lang="en-GB" smtClean="0"/>
              <a:t>31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13F47-1120-48DE-90C6-AA833649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1197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A330B3-6EF5-4854-A183-447EC6329E64}" type="datetimeFigureOut">
              <a:rPr lang="en-GB" smtClean="0"/>
              <a:t>31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D13F47-1120-48DE-90C6-AA833649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6547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13" Type="http://schemas.openxmlformats.org/officeDocument/2006/relationships/image" Target="../media/image31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12" Type="http://schemas.openxmlformats.org/officeDocument/2006/relationships/image" Target="../media/image30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11" Type="http://schemas.openxmlformats.org/officeDocument/2006/relationships/image" Target="../media/image29.png"/><Relationship Id="rId5" Type="http://schemas.openxmlformats.org/officeDocument/2006/relationships/image" Target="../media/image23.png"/><Relationship Id="rId10" Type="http://schemas.openxmlformats.org/officeDocument/2006/relationships/image" Target="../media/image28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13" Type="http://schemas.openxmlformats.org/officeDocument/2006/relationships/image" Target="../media/image43.png"/><Relationship Id="rId3" Type="http://schemas.openxmlformats.org/officeDocument/2006/relationships/image" Target="../media/image33.png"/><Relationship Id="rId7" Type="http://schemas.openxmlformats.org/officeDocument/2006/relationships/image" Target="../media/image37.png"/><Relationship Id="rId12" Type="http://schemas.openxmlformats.org/officeDocument/2006/relationships/image" Target="../media/image42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png"/><Relationship Id="rId11" Type="http://schemas.openxmlformats.org/officeDocument/2006/relationships/image" Target="../media/image41.png"/><Relationship Id="rId5" Type="http://schemas.openxmlformats.org/officeDocument/2006/relationships/image" Target="../media/image35.png"/><Relationship Id="rId10" Type="http://schemas.openxmlformats.org/officeDocument/2006/relationships/image" Target="../media/image40.png"/><Relationship Id="rId4" Type="http://schemas.openxmlformats.org/officeDocument/2006/relationships/image" Target="../media/image34.png"/><Relationship Id="rId9" Type="http://schemas.openxmlformats.org/officeDocument/2006/relationships/image" Target="../media/image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6792" y="62405"/>
            <a:ext cx="4126767" cy="39967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068960" y="4058652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Distance from TSS</a:t>
            </a:r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 rot="16200000">
            <a:off x="323262" y="1745002"/>
            <a:ext cx="2097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Number of peaks</a:t>
            </a:r>
            <a:endParaRPr lang="en-GB" dirty="0"/>
          </a:p>
        </p:txBody>
      </p:sp>
      <p:sp>
        <p:nvSpPr>
          <p:cNvPr id="5" name="TextBox 4"/>
          <p:cNvSpPr txBox="1"/>
          <p:nvPr/>
        </p:nvSpPr>
        <p:spPr>
          <a:xfrm>
            <a:off x="4149080" y="8774668"/>
            <a:ext cx="2710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GB" b="1" dirty="0">
                <a:latin typeface="Times New Roman" pitchFamily="18" charset="0"/>
                <a:cs typeface="Times New Roman" pitchFamily="18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8405245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149080" y="8774668"/>
            <a:ext cx="2710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Times New Roman" pitchFamily="18" charset="0"/>
                <a:cs typeface="Times New Roman" pitchFamily="18" charset="0"/>
              </a:rPr>
              <a:t>Supplementary Figure 2</a:t>
            </a:r>
            <a:endParaRPr lang="en-GB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-586598" y="659025"/>
            <a:ext cx="14932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itchFamily="18" charset="0"/>
                <a:cs typeface="Times New Roman" pitchFamily="18" charset="0"/>
              </a:rPr>
              <a:t>Promoter Fraction</a:t>
            </a:r>
            <a:endParaRPr lang="en-GB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-586598" y="4259425"/>
            <a:ext cx="14932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itchFamily="18" charset="0"/>
                <a:cs typeface="Times New Roman" pitchFamily="18" charset="0"/>
              </a:rPr>
              <a:t>5’ UTR Fraction</a:t>
            </a:r>
            <a:endParaRPr lang="en-GB" sz="10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5661248" y="77307"/>
            <a:ext cx="1140839" cy="822285"/>
            <a:chOff x="5960569" y="6630035"/>
            <a:chExt cx="1140839" cy="822285"/>
          </a:xfrm>
        </p:grpSpPr>
        <p:sp>
          <p:nvSpPr>
            <p:cNvPr id="16" name="Rectangle 15"/>
            <p:cNvSpPr/>
            <p:nvPr/>
          </p:nvSpPr>
          <p:spPr>
            <a:xfrm>
              <a:off x="5960569" y="6696236"/>
              <a:ext cx="144016" cy="10801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5960569" y="6984268"/>
              <a:ext cx="144016" cy="108012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b="1" dirty="0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5960569" y="7272300"/>
              <a:ext cx="144016" cy="108012"/>
            </a:xfrm>
            <a:prstGeom prst="rect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021288" y="6630035"/>
              <a:ext cx="7920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Times New Roman" pitchFamily="18" charset="0"/>
                  <a:cs typeface="Times New Roman" pitchFamily="18" charset="0"/>
                </a:rPr>
                <a:t>Singletons</a:t>
              </a:r>
              <a:endParaRPr lang="en-GB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021288" y="6918067"/>
              <a:ext cx="10801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err="1" smtClean="0">
                  <a:latin typeface="Times New Roman" pitchFamily="18" charset="0"/>
                  <a:cs typeface="Times New Roman" pitchFamily="18" charset="0"/>
                </a:rPr>
                <a:t>Combinatorials</a:t>
              </a:r>
              <a:endParaRPr lang="en-GB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021288" y="7206099"/>
              <a:ext cx="6926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Times New Roman" pitchFamily="18" charset="0"/>
                  <a:cs typeface="Times New Roman" pitchFamily="18" charset="0"/>
                </a:rPr>
                <a:t>Hotspots</a:t>
              </a:r>
              <a:endParaRPr lang="en-GB" sz="1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 rot="16200000">
            <a:off x="-586598" y="2603241"/>
            <a:ext cx="14932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itchFamily="18" charset="0"/>
                <a:cs typeface="Times New Roman" pitchFamily="18" charset="0"/>
              </a:rPr>
              <a:t>3’ UTR Fraction</a:t>
            </a:r>
            <a:endParaRPr lang="en-GB" sz="1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56" y="1763688"/>
            <a:ext cx="5340350" cy="19442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56" y="3635896"/>
            <a:ext cx="5340350" cy="18722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898" y="35496"/>
            <a:ext cx="5340350" cy="1800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56" y="5436096"/>
            <a:ext cx="5340350" cy="17677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485" y="7203802"/>
            <a:ext cx="5340350" cy="16956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TextBox 26"/>
          <p:cNvSpPr txBox="1"/>
          <p:nvPr/>
        </p:nvSpPr>
        <p:spPr>
          <a:xfrm rot="16200000">
            <a:off x="-586598" y="5987617"/>
            <a:ext cx="14932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itchFamily="18" charset="0"/>
                <a:cs typeface="Times New Roman" pitchFamily="18" charset="0"/>
              </a:rPr>
              <a:t>exon Fraction</a:t>
            </a:r>
            <a:endParaRPr lang="en-GB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-586598" y="7806707"/>
            <a:ext cx="14932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itchFamily="18" charset="0"/>
                <a:cs typeface="Times New Roman" pitchFamily="18" charset="0"/>
              </a:rPr>
              <a:t>Intron Fraction</a:t>
            </a:r>
            <a:endParaRPr lang="en-GB" sz="10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67561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149080" y="8774668"/>
            <a:ext cx="2710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Times New Roman" pitchFamily="18" charset="0"/>
                <a:cs typeface="Times New Roman" pitchFamily="18" charset="0"/>
              </a:rPr>
              <a:t>Supplementary Figure 3</a:t>
            </a:r>
            <a:endParaRPr lang="en-GB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" y="-45804"/>
            <a:ext cx="404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9" name="Oval 8"/>
          <p:cNvSpPr/>
          <p:nvPr/>
        </p:nvSpPr>
        <p:spPr>
          <a:xfrm>
            <a:off x="2627458" y="408829"/>
            <a:ext cx="1304313" cy="12410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Oval 9"/>
          <p:cNvSpPr/>
          <p:nvPr/>
        </p:nvSpPr>
        <p:spPr>
          <a:xfrm>
            <a:off x="2256197" y="940821"/>
            <a:ext cx="1332065" cy="12851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Oval 10"/>
          <p:cNvSpPr/>
          <p:nvPr/>
        </p:nvSpPr>
        <p:spPr>
          <a:xfrm>
            <a:off x="3012282" y="940822"/>
            <a:ext cx="1339130" cy="1285112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TextBox 11"/>
          <p:cNvSpPr txBox="1"/>
          <p:nvPr/>
        </p:nvSpPr>
        <p:spPr>
          <a:xfrm>
            <a:off x="2609528" y="200877"/>
            <a:ext cx="1453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Ang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et. al., 2011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094988" y="1270665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996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767236" y="1054641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63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415308" y="1054641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558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022980" y="1630705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1307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072454" y="622593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682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631332" y="1630705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12662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407196" y="1630705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394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-932"/>
          <a:stretch/>
        </p:blipFill>
        <p:spPr bwMode="auto">
          <a:xfrm>
            <a:off x="908720" y="2668434"/>
            <a:ext cx="4373239" cy="14241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028" y="4427985"/>
            <a:ext cx="4326862" cy="13776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2650254" y="2627784"/>
            <a:ext cx="1210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ES (Ng dataset) 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528438" y="4499992"/>
            <a:ext cx="16206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ES (Young dataset)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471092" y="2145673"/>
            <a:ext cx="1453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Chen et. al., 2008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631332" y="2124308"/>
            <a:ext cx="1453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Marson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et. al., 2008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399635" y="3208878"/>
            <a:ext cx="9455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Fraction of peak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471643" y="5009078"/>
            <a:ext cx="9455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Fraction of peak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204864" y="4037747"/>
            <a:ext cx="28083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Oct4 peaks called in number of experiments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276872" y="5765939"/>
            <a:ext cx="2736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Oct4 peaks called in number of experiments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451819" y="-36512"/>
            <a:ext cx="1611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Oct4 </a:t>
            </a:r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ChIP-seq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peaks 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2009" y="2483768"/>
            <a:ext cx="404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6783889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592" y="251520"/>
            <a:ext cx="6633408" cy="37303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640" y="4067944"/>
            <a:ext cx="2038350" cy="390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319116" y="8820472"/>
            <a:ext cx="2710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Times New Roman" pitchFamily="18" charset="0"/>
                <a:cs typeface="Times New Roman" pitchFamily="18" charset="0"/>
              </a:rPr>
              <a:t>Supplementary Figure 4</a:t>
            </a:r>
            <a:endParaRPr lang="en-GB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46502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20465824"/>
              </p:ext>
            </p:extLst>
          </p:nvPr>
        </p:nvGraphicFramePr>
        <p:xfrm>
          <a:off x="418356" y="5790063"/>
          <a:ext cx="6106988" cy="319233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2151"/>
                <a:gridCol w="756895"/>
                <a:gridCol w="5087942"/>
              </a:tblGrid>
              <a:tr h="1852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</a:t>
                      </a:r>
                      <a:endParaRPr lang="en-GB" sz="7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85134" marR="85134" marT="42567" marB="42567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type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85134" marR="85134" marT="42567" marB="42567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riched cis-regulatory motif</a:t>
                      </a:r>
                      <a:endParaRPr lang="en-GB" sz="7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85134" marR="85134" marT="42567" marB="42567"/>
                </a:tc>
              </a:tr>
              <a:tr h="21184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cells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Foxo1</a:t>
                      </a:r>
                      <a:endParaRPr lang="en-GB" sz="7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85134" marR="85134" marT="42567" marB="42567"/>
                </a:tc>
              </a:tr>
              <a:tr h="41492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dritic cells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Fli1, ELF1, Elk4, Elk1, ETS, GABPA, ETV1, ETS1, Sp1, ERG, ELF5, EHF, KLF5, GFY-</a:t>
                      </a:r>
                      <a:r>
                        <a:rPr lang="en-GB" sz="70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Staf</a:t>
                      </a: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NFY, GFY, Klf4, PU.1, NRF1, SPDEF, PU.1-IRF, Atf1, ETS:RUNX, CRE, Usf2, ZNF143, Stat3, CEBP, E2F4, CLOCK, c-Jun-CRE, YY1, </a:t>
                      </a:r>
                      <a:r>
                        <a:rPr lang="en-GB" sz="70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az</a:t>
                      </a: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GB" sz="70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JunD</a:t>
                      </a: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, bHLHE40, USF1, c-</a:t>
                      </a:r>
                      <a:r>
                        <a:rPr lang="en-GB" sz="70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yc</a:t>
                      </a: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, IRF1</a:t>
                      </a:r>
                      <a:endParaRPr lang="en-GB" sz="7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85134" marR="85134" marT="42567" marB="42567"/>
                </a:tc>
              </a:tr>
              <a:tr h="21184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ythroid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Gata1, Gata2, Gata4, EHF, GATA3, ERG, ETV1</a:t>
                      </a:r>
                      <a:endParaRPr lang="en-GB" sz="7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85134" marR="85134" marT="42567" marB="42567"/>
                </a:tc>
              </a:tr>
              <a:tr h="21184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 (Ng. et. al)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-</a:t>
                      </a:r>
                      <a:endParaRPr lang="en-GB" sz="7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85134" marR="85134" marT="42567" marB="42567"/>
                </a:tc>
              </a:tr>
              <a:tr h="326662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 (Young et. al.)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Elk1, ELF1, ETS, Fli1, Elk4, NRF1, NFY, ETV1, KLF5, GABPA, NRF1, Sp1, ZNF143|STAF, TEAD, EWS:FLI1-fusion, ETS1, BORIS, Klf4, TATA-Box, Atf1, ERG, EKLF, GFY-</a:t>
                      </a:r>
                      <a:r>
                        <a:rPr lang="en-GB" sz="70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Staf</a:t>
                      </a:r>
                      <a:endParaRPr lang="en-GB" sz="7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85134" marR="85134" marT="42567" marB="42567"/>
                </a:tc>
              </a:tr>
              <a:tr h="30010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C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ETV1, GABPA, ERG, ETS1, Gata4, Gata2, Fli1, Elk4, Gata1, KLF5, Elk1, EHF, GATA3, ELF1, EWS:FLI1-fusion, PU.1, Sp1, ETS, RUNX1, PU.1-IRF, RUNX</a:t>
                      </a:r>
                      <a:endParaRPr lang="en-GB" sz="7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85134" marR="85134" marT="42567" marB="42567"/>
                </a:tc>
              </a:tr>
              <a:tr h="21184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rophage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-</a:t>
                      </a:r>
                      <a:endParaRPr lang="en-GB" sz="7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85134" marR="85134" marT="42567" marB="42567"/>
                </a:tc>
              </a:tr>
              <a:tr h="30010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L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Elk4, Elk1, NFY, USF1, CLOCK, ELF1, bHLHE40, Fli1, c-</a:t>
                      </a:r>
                      <a:r>
                        <a:rPr lang="en-GB" sz="70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yc</a:t>
                      </a: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, Usf2, GABPA, n-</a:t>
                      </a:r>
                      <a:r>
                        <a:rPr lang="en-GB" sz="70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yc</a:t>
                      </a: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, ETS, ETV1, E-box, Max, Sp1, KLF5, ETS1, ERG, BMAL1, NRF1, GFY-</a:t>
                      </a:r>
                      <a:r>
                        <a:rPr lang="en-GB" sz="70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Staf</a:t>
                      </a: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, NPAS2, EWS:FLI1-fusion, c-</a:t>
                      </a:r>
                      <a:r>
                        <a:rPr lang="en-GB" sz="70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yc</a:t>
                      </a: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, CRE, GFY, EHF, YY1, ELF5, GFX, MYB, </a:t>
                      </a:r>
                      <a:endParaRPr lang="en-GB" sz="7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85134" marR="85134" marT="42567" marB="42567"/>
                </a:tc>
              </a:tr>
              <a:tr h="21184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K progenitors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Gata1, Gata2</a:t>
                      </a:r>
                      <a:endParaRPr lang="en-GB" sz="7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85134" marR="85134" marT="42567" marB="42567"/>
                </a:tc>
              </a:tr>
              <a:tr h="30010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cells</a:t>
                      </a:r>
                      <a:endParaRPr lang="en-GB" sz="7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3850" marR="63850" marT="56756" marB="56756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ELF1, Elk1, Elk4, Fli1, GABPA, ETS, ETV1, ETS1, ERG, EWS:FLI1-fusion, GFY-</a:t>
                      </a:r>
                      <a:r>
                        <a:rPr lang="en-GB" sz="70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Staf</a:t>
                      </a:r>
                      <a:r>
                        <a:rPr lang="en-GB" sz="7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, GFY, EHF, ELF5, STAT5, STAT1, SPDEF, Stat3, KLF5, Sp1, NRF1, ZNF143|STAF, ETS:RUNX, NFY, NRF1, STAT4, Stat3+il21, PU.1-IRF, Atf1</a:t>
                      </a:r>
                      <a:endParaRPr lang="en-GB" sz="7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85134" marR="85134" marT="42567" marB="42567"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4624" y="-108520"/>
            <a:ext cx="404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4817364"/>
              </p:ext>
            </p:extLst>
          </p:nvPr>
        </p:nvGraphicFramePr>
        <p:xfrm>
          <a:off x="432643" y="35496"/>
          <a:ext cx="6308724" cy="571280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02908"/>
                <a:gridCol w="2102908"/>
                <a:gridCol w="2102908"/>
              </a:tblGrid>
              <a:tr h="288032"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B cells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Erythroid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 smtClean="0"/>
                        <a:t>HPC</a:t>
                      </a:r>
                      <a:endParaRPr lang="en-GB" dirty="0"/>
                    </a:p>
                  </a:txBody>
                  <a:tcPr/>
                </a:tc>
              </a:tr>
              <a:tr h="1782349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1782349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1782349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196752" y="3923928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CTCF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64704" y="2164252"/>
            <a:ext cx="1355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Runx (TGYGGT)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832866" y="2164252"/>
            <a:ext cx="17644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Scl-Gata (TG(9N)GATA)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284984" y="2164252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Gfi (AATC)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1917121" y="1151910"/>
            <a:ext cx="1656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Fraction of peaks with motif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-243697" y="2880101"/>
            <a:ext cx="1656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Fraction of peaks with motif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4076782" y="1151910"/>
            <a:ext cx="1656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Fraction of peaks with motif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-243697" y="1151909"/>
            <a:ext cx="1656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Fraction of peaks with motif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1917121" y="4680301"/>
            <a:ext cx="1656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Fraction of peaks with motif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-243698" y="4680301"/>
            <a:ext cx="1656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Fraction of peaks with motif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4076782" y="2880101"/>
            <a:ext cx="1656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Fraction of peaks with motif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1917121" y="2880102"/>
            <a:ext cx="1656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Fraction of peaks with motif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4076782" y="4680302"/>
            <a:ext cx="1656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Fraction of peaks with motif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052736" y="375482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Gata (GATA)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501008" y="3923928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CTCF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517232" y="3923928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CTCF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140968" y="375482"/>
            <a:ext cx="1296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Ebox (CANNTG)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157192" y="375482"/>
            <a:ext cx="1296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Meis (TGACAS)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2" name="Group 31"/>
          <p:cNvGrpSpPr/>
          <p:nvPr/>
        </p:nvGrpSpPr>
        <p:grpSpPr>
          <a:xfrm>
            <a:off x="5286132" y="4096770"/>
            <a:ext cx="1239212" cy="259206"/>
            <a:chOff x="6251369" y="2483768"/>
            <a:chExt cx="635912" cy="259206"/>
          </a:xfrm>
        </p:grpSpPr>
        <p:cxnSp>
          <p:nvCxnSpPr>
            <p:cNvPr id="33" name="Straight Connector 32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6251369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 flipH="1">
              <a:off x="6251369" y="2627784"/>
              <a:ext cx="562009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6455234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3197900" y="4067944"/>
            <a:ext cx="1239212" cy="259206"/>
            <a:chOff x="6251369" y="2483768"/>
            <a:chExt cx="635912" cy="259206"/>
          </a:xfrm>
        </p:grpSpPr>
        <p:cxnSp>
          <p:nvCxnSpPr>
            <p:cNvPr id="38" name="Straight Connector 37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6251369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 flipH="1">
              <a:off x="6251369" y="2627784"/>
              <a:ext cx="562009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6455234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980728" y="4067944"/>
            <a:ext cx="1239212" cy="259206"/>
            <a:chOff x="6251369" y="2483768"/>
            <a:chExt cx="635912" cy="259206"/>
          </a:xfrm>
        </p:grpSpPr>
        <p:cxnSp>
          <p:nvCxnSpPr>
            <p:cNvPr id="43" name="Straight Connector 42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6251369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 flipH="1">
              <a:off x="6251369" y="2627784"/>
              <a:ext cx="562009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6455234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980728" y="2440586"/>
            <a:ext cx="1239212" cy="259206"/>
            <a:chOff x="6251369" y="2483768"/>
            <a:chExt cx="635912" cy="259206"/>
          </a:xfrm>
        </p:grpSpPr>
        <p:cxnSp>
          <p:nvCxnSpPr>
            <p:cNvPr id="48" name="Straight Connector 47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6251369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 flipH="1">
              <a:off x="6251369" y="2627784"/>
              <a:ext cx="562009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6455234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3068960" y="2368578"/>
            <a:ext cx="1239212" cy="259206"/>
            <a:chOff x="6251369" y="2483768"/>
            <a:chExt cx="635912" cy="259206"/>
          </a:xfrm>
        </p:grpSpPr>
        <p:cxnSp>
          <p:nvCxnSpPr>
            <p:cNvPr id="53" name="Straight Connector 52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6251369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 flipH="1">
              <a:off x="6251369" y="2627784"/>
              <a:ext cx="562009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6455234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57" name="Group 56"/>
          <p:cNvGrpSpPr/>
          <p:nvPr/>
        </p:nvGrpSpPr>
        <p:grpSpPr>
          <a:xfrm>
            <a:off x="5286132" y="2368578"/>
            <a:ext cx="1239212" cy="259206"/>
            <a:chOff x="6251369" y="2483768"/>
            <a:chExt cx="635912" cy="259206"/>
          </a:xfrm>
        </p:grpSpPr>
        <p:cxnSp>
          <p:nvCxnSpPr>
            <p:cNvPr id="58" name="Straight Connector 57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>
              <a:off x="6251369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 flipH="1">
              <a:off x="6251369" y="2627784"/>
              <a:ext cx="562009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/>
            <p:cNvSpPr txBox="1"/>
            <p:nvPr/>
          </p:nvSpPr>
          <p:spPr>
            <a:xfrm>
              <a:off x="6455234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62" name="Group 61"/>
          <p:cNvGrpSpPr/>
          <p:nvPr/>
        </p:nvGrpSpPr>
        <p:grpSpPr>
          <a:xfrm>
            <a:off x="5229200" y="539552"/>
            <a:ext cx="1239212" cy="259206"/>
            <a:chOff x="6251369" y="2483768"/>
            <a:chExt cx="635912" cy="259206"/>
          </a:xfrm>
        </p:grpSpPr>
        <p:cxnSp>
          <p:nvCxnSpPr>
            <p:cNvPr id="63" name="Straight Connector 62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>
              <a:off x="6251369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 flipH="1">
              <a:off x="6251369" y="2627784"/>
              <a:ext cx="562009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>
              <a:off x="6455234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67" name="Group 66"/>
          <p:cNvGrpSpPr/>
          <p:nvPr/>
        </p:nvGrpSpPr>
        <p:grpSpPr>
          <a:xfrm>
            <a:off x="3140968" y="539552"/>
            <a:ext cx="1239212" cy="259206"/>
            <a:chOff x="6251369" y="2483768"/>
            <a:chExt cx="635912" cy="259206"/>
          </a:xfrm>
        </p:grpSpPr>
        <p:cxnSp>
          <p:nvCxnSpPr>
            <p:cNvPr id="68" name="Straight Connector 67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6251369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 flipH="1">
              <a:off x="6251369" y="2627784"/>
              <a:ext cx="562009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>
              <a:off x="6455234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sp>
        <p:nvSpPr>
          <p:cNvPr id="77" name="TextBox 76"/>
          <p:cNvSpPr txBox="1"/>
          <p:nvPr/>
        </p:nvSpPr>
        <p:spPr>
          <a:xfrm>
            <a:off x="696774" y="5561642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Combinatorials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2847489" y="5542592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Combinatorials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954771" y="5546204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Combinatorials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5013176" y="3780492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Combinatorials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2785006" y="3779912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Combinatorials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696774" y="3779912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Combinatorials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620688" y="1979712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Combinatorials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2780928" y="1980292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Combinatorials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4869160" y="1979712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Combinatorials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44624" y="5642828"/>
            <a:ext cx="404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8861" y="623013"/>
            <a:ext cx="1511079" cy="13572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6774" y="2653654"/>
            <a:ext cx="1523165" cy="11622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6141" y="4355976"/>
            <a:ext cx="1682739" cy="12868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2647" y="741163"/>
            <a:ext cx="1604465" cy="12883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2936" y="2603515"/>
            <a:ext cx="1527244" cy="12056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5300" y="4355977"/>
            <a:ext cx="1637032" cy="12241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4771" y="755576"/>
            <a:ext cx="1498566" cy="12920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83839" y="2644023"/>
            <a:ext cx="1541505" cy="12078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8667" y="4328332"/>
            <a:ext cx="1598685" cy="12794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7" name="TextBox 86"/>
          <p:cNvSpPr txBox="1"/>
          <p:nvPr/>
        </p:nvSpPr>
        <p:spPr>
          <a:xfrm>
            <a:off x="4319116" y="8811180"/>
            <a:ext cx="2710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Times New Roman" pitchFamily="18" charset="0"/>
                <a:cs typeface="Times New Roman" pitchFamily="18" charset="0"/>
              </a:rPr>
              <a:t>Supplementary Figure 5</a:t>
            </a:r>
            <a:endParaRPr lang="en-GB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94797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9535672"/>
              </p:ext>
            </p:extLst>
          </p:nvPr>
        </p:nvGraphicFramePr>
        <p:xfrm>
          <a:off x="404664" y="107501"/>
          <a:ext cx="6192687" cy="866716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64229"/>
                <a:gridCol w="2064229"/>
                <a:gridCol w="2064229"/>
              </a:tblGrid>
              <a:tr h="518719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ES (Ng data set)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ES (Young data set)</a:t>
                      </a:r>
                      <a:endParaRPr lang="en-GB" dirty="0"/>
                    </a:p>
                  </a:txBody>
                  <a:tcPr/>
                </a:tc>
              </a:tr>
              <a:tr h="1358075">
                <a:tc>
                  <a:txBody>
                    <a:bodyPr/>
                    <a:lstStyle/>
                    <a:p>
                      <a:r>
                        <a:rPr lang="en-GB" dirty="0" smtClean="0"/>
                        <a:t>High methylated </a:t>
                      </a:r>
                      <a:r>
                        <a:rPr lang="en-GB" dirty="0" err="1" smtClean="0"/>
                        <a:t>CpG</a:t>
                      </a:r>
                      <a:r>
                        <a:rPr lang="en-GB" dirty="0" smtClean="0"/>
                        <a:t> islands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358075">
                <a:tc>
                  <a:txBody>
                    <a:bodyPr/>
                    <a:lstStyle/>
                    <a:p>
                      <a:r>
                        <a:rPr lang="en-GB" dirty="0" smtClean="0"/>
                        <a:t>Low methylated </a:t>
                      </a:r>
                      <a:r>
                        <a:rPr lang="en-GB" dirty="0" err="1" smtClean="0"/>
                        <a:t>CpG</a:t>
                      </a:r>
                      <a:r>
                        <a:rPr lang="en-GB" dirty="0" smtClean="0"/>
                        <a:t> islands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358075">
                <a:tc>
                  <a:txBody>
                    <a:bodyPr/>
                    <a:lstStyle/>
                    <a:p>
                      <a:r>
                        <a:rPr lang="en-GB" dirty="0" smtClean="0"/>
                        <a:t>H3K4me3</a:t>
                      </a:r>
                    </a:p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358075">
                <a:tc>
                  <a:txBody>
                    <a:bodyPr/>
                    <a:lstStyle/>
                    <a:p>
                      <a:r>
                        <a:rPr lang="en-GB" dirty="0" smtClean="0"/>
                        <a:t>H3K27ac</a:t>
                      </a:r>
                    </a:p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358075">
                <a:tc>
                  <a:txBody>
                    <a:bodyPr/>
                    <a:lstStyle/>
                    <a:p>
                      <a:r>
                        <a:rPr lang="en-GB" dirty="0" smtClean="0"/>
                        <a:t>H3K27me3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358075">
                <a:tc>
                  <a:txBody>
                    <a:bodyPr/>
                    <a:lstStyle/>
                    <a:p>
                      <a:r>
                        <a:rPr lang="en-GB" dirty="0" smtClean="0"/>
                        <a:t>RNA</a:t>
                      </a:r>
                      <a:r>
                        <a:rPr lang="en-GB" baseline="0" dirty="0" smtClean="0"/>
                        <a:t> </a:t>
                      </a:r>
                      <a:r>
                        <a:rPr lang="en-GB" baseline="0" dirty="0" err="1" smtClean="0"/>
                        <a:t>seq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149080" y="8774668"/>
            <a:ext cx="2710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Times New Roman" pitchFamily="18" charset="0"/>
                <a:cs typeface="Times New Roman" pitchFamily="18" charset="0"/>
              </a:rPr>
              <a:t>Supplementary Figure 6</a:t>
            </a:r>
            <a:endParaRPr lang="en-GB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2636" y="683568"/>
            <a:ext cx="1440160" cy="1222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6350" y="3419872"/>
            <a:ext cx="1492732" cy="12629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9220" y="2044699"/>
            <a:ext cx="1426993" cy="12134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2636" y="4716016"/>
            <a:ext cx="1440160" cy="12151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6351" y="6106709"/>
            <a:ext cx="1492730" cy="12630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2867" y="7452320"/>
            <a:ext cx="1399698" cy="12593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1481" y="683568"/>
            <a:ext cx="1438576" cy="1222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6545" y="2056449"/>
            <a:ext cx="1428449" cy="12194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09593" y="3453616"/>
            <a:ext cx="1402353" cy="11903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 rot="16200000">
            <a:off x="2096852" y="1216224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Number of CGIs</a:t>
            </a:r>
            <a:endParaRPr lang="en-GB" sz="9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2096852" y="2512368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Number of CGIs</a:t>
            </a:r>
            <a:endParaRPr lang="en-GB" sz="9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4149080" y="2512368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Number of CGIs</a:t>
            </a:r>
            <a:endParaRPr lang="en-GB" sz="900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4149080" y="1144216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Number of CGIs</a:t>
            </a:r>
            <a:endParaRPr lang="en-GB" sz="9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2096852" y="3952528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Number of reads</a:t>
            </a:r>
            <a:endParaRPr lang="en-GB" sz="9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2096852" y="5248672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Number of reads</a:t>
            </a:r>
            <a:endParaRPr lang="en-GB" sz="9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2096852" y="6616823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Number of reads</a:t>
            </a:r>
            <a:endParaRPr lang="en-GB" sz="9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2096852" y="7912968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Mean log2 FPKM</a:t>
            </a:r>
            <a:endParaRPr lang="en-GB" sz="900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4149080" y="3880521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Number of reads</a:t>
            </a:r>
            <a:endParaRPr lang="en-GB" sz="900" dirty="0"/>
          </a:p>
        </p:txBody>
      </p:sp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9443" y="4750524"/>
            <a:ext cx="1462653" cy="1232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6010" y="6228183"/>
            <a:ext cx="1389519" cy="11663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9958" y="7510911"/>
            <a:ext cx="1301622" cy="1184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30" name="Group 29"/>
          <p:cNvGrpSpPr/>
          <p:nvPr/>
        </p:nvGrpSpPr>
        <p:grpSpPr>
          <a:xfrm>
            <a:off x="5085184" y="3635896"/>
            <a:ext cx="1008116" cy="259206"/>
            <a:chOff x="6424752" y="2483768"/>
            <a:chExt cx="517323" cy="259206"/>
          </a:xfrm>
        </p:grpSpPr>
        <p:cxnSp>
          <p:nvCxnSpPr>
            <p:cNvPr id="31" name="Straight Connector 30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6424752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 flipH="1">
              <a:off x="6424754" y="2627784"/>
              <a:ext cx="38862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6510028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3097535" y="3645421"/>
            <a:ext cx="1008116" cy="259206"/>
            <a:chOff x="6424752" y="2483768"/>
            <a:chExt cx="517323" cy="259206"/>
          </a:xfrm>
        </p:grpSpPr>
        <p:cxnSp>
          <p:nvCxnSpPr>
            <p:cNvPr id="39" name="Straight Connector 38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6424752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 flipH="1">
              <a:off x="6424754" y="2627784"/>
              <a:ext cx="38862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6510028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3140964" y="2339752"/>
            <a:ext cx="1008116" cy="259206"/>
            <a:chOff x="6424752" y="2483768"/>
            <a:chExt cx="517323" cy="259206"/>
          </a:xfrm>
        </p:grpSpPr>
        <p:cxnSp>
          <p:nvCxnSpPr>
            <p:cNvPr id="44" name="Straight Connector 43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6424752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 flipH="1">
              <a:off x="6424754" y="2627784"/>
              <a:ext cx="38862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6510028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5119088" y="2195736"/>
            <a:ext cx="1008116" cy="259206"/>
            <a:chOff x="6424752" y="2483768"/>
            <a:chExt cx="517323" cy="259206"/>
          </a:xfrm>
        </p:grpSpPr>
        <p:cxnSp>
          <p:nvCxnSpPr>
            <p:cNvPr id="49" name="Straight Connector 48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6424752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 flipH="1">
              <a:off x="6424754" y="2627784"/>
              <a:ext cx="38862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/>
            <p:cNvSpPr txBox="1"/>
            <p:nvPr/>
          </p:nvSpPr>
          <p:spPr>
            <a:xfrm>
              <a:off x="6510028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53" name="Group 52"/>
          <p:cNvGrpSpPr/>
          <p:nvPr/>
        </p:nvGrpSpPr>
        <p:grpSpPr>
          <a:xfrm>
            <a:off x="5085184" y="4816850"/>
            <a:ext cx="1008116" cy="259206"/>
            <a:chOff x="6424752" y="2483768"/>
            <a:chExt cx="517323" cy="259206"/>
          </a:xfrm>
        </p:grpSpPr>
        <p:cxnSp>
          <p:nvCxnSpPr>
            <p:cNvPr id="54" name="Straight Connector 53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>
              <a:off x="6424752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 flipH="1">
              <a:off x="6424754" y="2627784"/>
              <a:ext cx="38862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6510028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58" name="Group 57"/>
          <p:cNvGrpSpPr/>
          <p:nvPr/>
        </p:nvGrpSpPr>
        <p:grpSpPr>
          <a:xfrm>
            <a:off x="3140964" y="4969250"/>
            <a:ext cx="1008116" cy="259206"/>
            <a:chOff x="6424752" y="2483768"/>
            <a:chExt cx="517323" cy="259206"/>
          </a:xfrm>
        </p:grpSpPr>
        <p:cxnSp>
          <p:nvCxnSpPr>
            <p:cNvPr id="59" name="Straight Connector 58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>
              <a:off x="6424752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 flipH="1">
              <a:off x="6424754" y="2627784"/>
              <a:ext cx="38862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6510028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sp>
        <p:nvSpPr>
          <p:cNvPr id="63" name="TextBox 62"/>
          <p:cNvSpPr txBox="1"/>
          <p:nvPr/>
        </p:nvSpPr>
        <p:spPr>
          <a:xfrm rot="16200000">
            <a:off x="4149080" y="7984976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Mean log2 FPKM</a:t>
            </a:r>
            <a:endParaRPr lang="en-GB" sz="900" dirty="0"/>
          </a:p>
        </p:txBody>
      </p:sp>
      <p:grpSp>
        <p:nvGrpSpPr>
          <p:cNvPr id="64" name="Group 63"/>
          <p:cNvGrpSpPr/>
          <p:nvPr/>
        </p:nvGrpSpPr>
        <p:grpSpPr>
          <a:xfrm>
            <a:off x="3068960" y="7553154"/>
            <a:ext cx="1008116" cy="259206"/>
            <a:chOff x="6424752" y="2483768"/>
            <a:chExt cx="517323" cy="259206"/>
          </a:xfrm>
        </p:grpSpPr>
        <p:cxnSp>
          <p:nvCxnSpPr>
            <p:cNvPr id="65" name="Straight Connector 64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6424752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 flipH="1">
              <a:off x="6424754" y="2627784"/>
              <a:ext cx="38862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/>
            <p:cNvSpPr txBox="1"/>
            <p:nvPr/>
          </p:nvSpPr>
          <p:spPr>
            <a:xfrm>
              <a:off x="6510028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69" name="Group 68"/>
          <p:cNvGrpSpPr/>
          <p:nvPr/>
        </p:nvGrpSpPr>
        <p:grpSpPr>
          <a:xfrm>
            <a:off x="5013172" y="7705554"/>
            <a:ext cx="1008116" cy="259206"/>
            <a:chOff x="6424752" y="2483768"/>
            <a:chExt cx="517323" cy="259206"/>
          </a:xfrm>
        </p:grpSpPr>
        <p:cxnSp>
          <p:nvCxnSpPr>
            <p:cNvPr id="70" name="Straight Connector 69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>
              <a:off x="6424752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 flipH="1">
              <a:off x="6424754" y="2627784"/>
              <a:ext cx="38862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/>
            <p:cNvSpPr txBox="1"/>
            <p:nvPr/>
          </p:nvSpPr>
          <p:spPr>
            <a:xfrm>
              <a:off x="6510028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5013176" y="6300192"/>
            <a:ext cx="1008116" cy="259206"/>
            <a:chOff x="6424752" y="2483768"/>
            <a:chExt cx="517323" cy="259206"/>
          </a:xfrm>
        </p:grpSpPr>
        <p:cxnSp>
          <p:nvCxnSpPr>
            <p:cNvPr id="75" name="Straight Connector 74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>
              <a:off x="6424752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 flipH="1">
              <a:off x="6424754" y="2627784"/>
              <a:ext cx="38862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/>
            <p:cNvSpPr txBox="1"/>
            <p:nvPr/>
          </p:nvSpPr>
          <p:spPr>
            <a:xfrm>
              <a:off x="6510028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sp>
        <p:nvSpPr>
          <p:cNvPr id="79" name="TextBox 78"/>
          <p:cNvSpPr txBox="1"/>
          <p:nvPr/>
        </p:nvSpPr>
        <p:spPr>
          <a:xfrm rot="16200000">
            <a:off x="4149080" y="5248673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Number of reads</a:t>
            </a:r>
            <a:endParaRPr lang="en-GB" sz="900" dirty="0"/>
          </a:p>
        </p:txBody>
      </p:sp>
      <p:sp>
        <p:nvSpPr>
          <p:cNvPr id="80" name="TextBox 79"/>
          <p:cNvSpPr txBox="1"/>
          <p:nvPr/>
        </p:nvSpPr>
        <p:spPr>
          <a:xfrm rot="16200000">
            <a:off x="4149080" y="6616824"/>
            <a:ext cx="1008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Number of reads</a:t>
            </a:r>
            <a:endParaRPr lang="en-GB" sz="900" dirty="0"/>
          </a:p>
        </p:txBody>
      </p:sp>
      <p:grpSp>
        <p:nvGrpSpPr>
          <p:cNvPr id="81" name="Group 80"/>
          <p:cNvGrpSpPr/>
          <p:nvPr/>
        </p:nvGrpSpPr>
        <p:grpSpPr>
          <a:xfrm>
            <a:off x="3045206" y="1044366"/>
            <a:ext cx="1008116" cy="259206"/>
            <a:chOff x="6424752" y="2483768"/>
            <a:chExt cx="517323" cy="259206"/>
          </a:xfrm>
        </p:grpSpPr>
        <p:cxnSp>
          <p:nvCxnSpPr>
            <p:cNvPr id="82" name="Straight Connector 81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>
              <a:off x="6424752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 flipH="1">
              <a:off x="6424754" y="2627784"/>
              <a:ext cx="38862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/>
            <p:cNvSpPr txBox="1"/>
            <p:nvPr/>
          </p:nvSpPr>
          <p:spPr>
            <a:xfrm>
              <a:off x="6510028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5048801" y="1018641"/>
            <a:ext cx="1008116" cy="259206"/>
            <a:chOff x="6424752" y="2483768"/>
            <a:chExt cx="517323" cy="259206"/>
          </a:xfrm>
        </p:grpSpPr>
        <p:cxnSp>
          <p:nvCxnSpPr>
            <p:cNvPr id="87" name="Straight Connector 86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/>
            <p:cNvCxnSpPr/>
            <p:nvPr/>
          </p:nvCxnSpPr>
          <p:spPr>
            <a:xfrm>
              <a:off x="6424752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/>
            <p:cNvCxnSpPr/>
            <p:nvPr/>
          </p:nvCxnSpPr>
          <p:spPr>
            <a:xfrm flipH="1">
              <a:off x="6424754" y="2627784"/>
              <a:ext cx="38862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>
              <a:off x="6510028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9856665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Table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262619"/>
              </p:ext>
            </p:extLst>
          </p:nvPr>
        </p:nvGraphicFramePr>
        <p:xfrm>
          <a:off x="116632" y="107504"/>
          <a:ext cx="4032448" cy="297544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48344"/>
                <a:gridCol w="1599928"/>
                <a:gridCol w="1584176"/>
              </a:tblGrid>
              <a:tr h="288031">
                <a:tc>
                  <a:txBody>
                    <a:bodyPr/>
                    <a:lstStyle/>
                    <a:p>
                      <a:pPr algn="ctr"/>
                      <a:endParaRPr lang="en-GB" sz="14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Oct4 (Hall et.al. )</a:t>
                      </a:r>
                      <a:endParaRPr lang="en-GB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Oct4 (</a:t>
                      </a:r>
                      <a:r>
                        <a:rPr lang="en-GB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Sharov</a:t>
                      </a:r>
                      <a:r>
                        <a:rPr lang="en-GB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 et. al.)</a:t>
                      </a:r>
                      <a:endParaRPr lang="en-GB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303327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Up regulated</a:t>
                      </a:r>
                    </a:p>
                    <a:p>
                      <a:pPr algn="ctr"/>
                      <a:r>
                        <a:rPr lang="en-GB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genes</a:t>
                      </a:r>
                    </a:p>
                    <a:p>
                      <a:pPr algn="ctr"/>
                      <a:endParaRPr lang="en-GB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4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4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367316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Down</a:t>
                      </a:r>
                      <a:r>
                        <a:rPr lang="en-GB" sz="12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regulated</a:t>
                      </a:r>
                    </a:p>
                    <a:p>
                      <a:pPr algn="ctr"/>
                      <a:r>
                        <a:rPr lang="en-GB" sz="12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genes</a:t>
                      </a:r>
                      <a:endParaRPr lang="en-GB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4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4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32" name="Table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5637849"/>
              </p:ext>
            </p:extLst>
          </p:nvPr>
        </p:nvGraphicFramePr>
        <p:xfrm>
          <a:off x="2636912" y="3155352"/>
          <a:ext cx="4032448" cy="297544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48344"/>
                <a:gridCol w="1599928"/>
                <a:gridCol w="1584176"/>
              </a:tblGrid>
              <a:tr h="288031">
                <a:tc>
                  <a:txBody>
                    <a:bodyPr/>
                    <a:lstStyle/>
                    <a:p>
                      <a:pPr algn="ctr"/>
                      <a:endParaRPr lang="en-GB" sz="14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Dnmt</a:t>
                      </a:r>
                      <a:endParaRPr lang="en-GB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smtClean="0">
                          <a:latin typeface="Times New Roman" pitchFamily="18" charset="0"/>
                          <a:cs typeface="Times New Roman" pitchFamily="18" charset="0"/>
                        </a:rPr>
                        <a:t>Setdb1</a:t>
                      </a:r>
                      <a:endParaRPr lang="en-GB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303327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Up regulated</a:t>
                      </a:r>
                    </a:p>
                    <a:p>
                      <a:pPr algn="ctr"/>
                      <a:r>
                        <a:rPr lang="en-GB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genes</a:t>
                      </a:r>
                    </a:p>
                    <a:p>
                      <a:pPr algn="ctr"/>
                      <a:endParaRPr lang="en-GB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4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4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367316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Down</a:t>
                      </a:r>
                      <a:r>
                        <a:rPr lang="en-GB" sz="12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regulated</a:t>
                      </a:r>
                    </a:p>
                    <a:p>
                      <a:pPr algn="ctr"/>
                      <a:r>
                        <a:rPr lang="en-GB" sz="12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genes</a:t>
                      </a:r>
                      <a:endParaRPr lang="en-GB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4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4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620688" y="3010939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af250</a:t>
            </a:r>
            <a:endParaRPr lang="en-GB" dirty="0"/>
          </a:p>
        </p:txBody>
      </p:sp>
      <p:sp>
        <p:nvSpPr>
          <p:cNvPr id="41" name="TextBox 40"/>
          <p:cNvSpPr txBox="1"/>
          <p:nvPr/>
        </p:nvSpPr>
        <p:spPr>
          <a:xfrm>
            <a:off x="692696" y="4585823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Hdac1</a:t>
            </a:r>
            <a:endParaRPr lang="en-GB" dirty="0"/>
          </a:p>
        </p:txBody>
      </p:sp>
      <p:sp>
        <p:nvSpPr>
          <p:cNvPr id="2065" name="TextBox 2064"/>
          <p:cNvSpPr txBox="1"/>
          <p:nvPr/>
        </p:nvSpPr>
        <p:spPr>
          <a:xfrm>
            <a:off x="6028968" y="611560"/>
            <a:ext cx="5506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Tcf4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149080" y="8774668"/>
            <a:ext cx="2710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Times New Roman" pitchFamily="18" charset="0"/>
                <a:cs typeface="Times New Roman" pitchFamily="18" charset="0"/>
              </a:rPr>
              <a:t>Supplementary Figure 7</a:t>
            </a:r>
            <a:endParaRPr lang="en-GB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088"/>
          <a:stretch/>
        </p:blipFill>
        <p:spPr bwMode="auto">
          <a:xfrm>
            <a:off x="633081" y="3309581"/>
            <a:ext cx="1283751" cy="11815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91" name="Group 90"/>
          <p:cNvGrpSpPr/>
          <p:nvPr/>
        </p:nvGrpSpPr>
        <p:grpSpPr>
          <a:xfrm>
            <a:off x="1268759" y="3169268"/>
            <a:ext cx="504057" cy="273719"/>
            <a:chOff x="6309320" y="2469255"/>
            <a:chExt cx="504057" cy="273719"/>
          </a:xfrm>
        </p:grpSpPr>
        <p:cxnSp>
          <p:nvCxnSpPr>
            <p:cNvPr id="92" name="Straight Connector 91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/>
            <p:cNvCxnSpPr/>
            <p:nvPr/>
          </p:nvCxnSpPr>
          <p:spPr>
            <a:xfrm>
              <a:off x="630932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/>
            <p:cNvCxnSpPr/>
            <p:nvPr/>
          </p:nvCxnSpPr>
          <p:spPr>
            <a:xfrm flipH="1">
              <a:off x="6309320" y="2627784"/>
              <a:ext cx="504057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/>
            <p:cNvSpPr txBox="1"/>
            <p:nvPr/>
          </p:nvSpPr>
          <p:spPr>
            <a:xfrm>
              <a:off x="6381329" y="2469255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grpSp>
        <p:nvGrpSpPr>
          <p:cNvPr id="96" name="Group 95"/>
          <p:cNvGrpSpPr/>
          <p:nvPr/>
        </p:nvGrpSpPr>
        <p:grpSpPr>
          <a:xfrm>
            <a:off x="1340768" y="4790141"/>
            <a:ext cx="504057" cy="259206"/>
            <a:chOff x="6309320" y="2483768"/>
            <a:chExt cx="504057" cy="259206"/>
          </a:xfrm>
        </p:grpSpPr>
        <p:cxnSp>
          <p:nvCxnSpPr>
            <p:cNvPr id="97" name="Straight Connector 96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/>
            <p:cNvCxnSpPr/>
            <p:nvPr/>
          </p:nvCxnSpPr>
          <p:spPr>
            <a:xfrm>
              <a:off x="630932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/>
            <p:cNvCxnSpPr/>
            <p:nvPr/>
          </p:nvCxnSpPr>
          <p:spPr>
            <a:xfrm flipH="1">
              <a:off x="6309320" y="2627784"/>
              <a:ext cx="504057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/>
            <p:cNvSpPr txBox="1"/>
            <p:nvPr/>
          </p:nvSpPr>
          <p:spPr>
            <a:xfrm>
              <a:off x="6381329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131"/>
          <a:stretch/>
        </p:blipFill>
        <p:spPr bwMode="auto">
          <a:xfrm>
            <a:off x="633081" y="4961044"/>
            <a:ext cx="1316171" cy="11724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912"/>
          <a:stretch/>
        </p:blipFill>
        <p:spPr bwMode="auto">
          <a:xfrm>
            <a:off x="3681027" y="3558314"/>
            <a:ext cx="1161550" cy="10275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074"/>
          <a:stretch/>
        </p:blipFill>
        <p:spPr bwMode="auto">
          <a:xfrm>
            <a:off x="3645024" y="4884137"/>
            <a:ext cx="1241822" cy="10915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075"/>
          <a:stretch/>
        </p:blipFill>
        <p:spPr bwMode="auto">
          <a:xfrm>
            <a:off x="5236656" y="3466499"/>
            <a:ext cx="1268759" cy="1119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477"/>
          <a:stretch/>
        </p:blipFill>
        <p:spPr bwMode="auto">
          <a:xfrm>
            <a:off x="5301208" y="4906659"/>
            <a:ext cx="1194682" cy="10690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86" name="Group 85"/>
          <p:cNvGrpSpPr/>
          <p:nvPr/>
        </p:nvGrpSpPr>
        <p:grpSpPr>
          <a:xfrm>
            <a:off x="5877272" y="4739528"/>
            <a:ext cx="504057" cy="259206"/>
            <a:chOff x="6309320" y="2483768"/>
            <a:chExt cx="504057" cy="259206"/>
          </a:xfrm>
        </p:grpSpPr>
        <p:cxnSp>
          <p:nvCxnSpPr>
            <p:cNvPr id="87" name="Straight Connector 86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/>
            <p:cNvCxnSpPr/>
            <p:nvPr/>
          </p:nvCxnSpPr>
          <p:spPr>
            <a:xfrm>
              <a:off x="630932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/>
            <p:cNvCxnSpPr/>
            <p:nvPr/>
          </p:nvCxnSpPr>
          <p:spPr>
            <a:xfrm flipH="1">
              <a:off x="6309320" y="2627784"/>
              <a:ext cx="504057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>
              <a:off x="6381329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5911"/>
          <a:stretch/>
        </p:blipFill>
        <p:spPr bwMode="auto">
          <a:xfrm>
            <a:off x="1112044" y="438815"/>
            <a:ext cx="1296144" cy="1188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56"/>
          <a:stretch/>
        </p:blipFill>
        <p:spPr bwMode="auto">
          <a:xfrm>
            <a:off x="1134562" y="1808198"/>
            <a:ext cx="1273626" cy="1141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01" name="Group 100"/>
          <p:cNvGrpSpPr/>
          <p:nvPr/>
        </p:nvGrpSpPr>
        <p:grpSpPr>
          <a:xfrm>
            <a:off x="1772815" y="1648498"/>
            <a:ext cx="504057" cy="259206"/>
            <a:chOff x="6309320" y="2483768"/>
            <a:chExt cx="504057" cy="259206"/>
          </a:xfrm>
        </p:grpSpPr>
        <p:cxnSp>
          <p:nvCxnSpPr>
            <p:cNvPr id="102" name="Straight Connector 101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/>
            <p:cNvCxnSpPr/>
            <p:nvPr/>
          </p:nvCxnSpPr>
          <p:spPr>
            <a:xfrm>
              <a:off x="630932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Connector 103"/>
            <p:cNvCxnSpPr/>
            <p:nvPr/>
          </p:nvCxnSpPr>
          <p:spPr>
            <a:xfrm flipH="1">
              <a:off x="6309320" y="2627784"/>
              <a:ext cx="504057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Box 104"/>
            <p:cNvSpPr txBox="1"/>
            <p:nvPr/>
          </p:nvSpPr>
          <p:spPr>
            <a:xfrm>
              <a:off x="6381329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pic>
        <p:nvPicPr>
          <p:cNvPr id="4" name="Picture 4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443"/>
          <a:stretch/>
        </p:blipFill>
        <p:spPr bwMode="auto">
          <a:xfrm>
            <a:off x="2780928" y="512054"/>
            <a:ext cx="1224136" cy="1115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37"/>
          <a:stretch/>
        </p:blipFill>
        <p:spPr bwMode="auto">
          <a:xfrm>
            <a:off x="2806969" y="1835210"/>
            <a:ext cx="1244059" cy="1113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06" name="Group 105"/>
          <p:cNvGrpSpPr/>
          <p:nvPr/>
        </p:nvGrpSpPr>
        <p:grpSpPr>
          <a:xfrm>
            <a:off x="3428999" y="1693008"/>
            <a:ext cx="504057" cy="259206"/>
            <a:chOff x="6309320" y="2483768"/>
            <a:chExt cx="504057" cy="259206"/>
          </a:xfrm>
        </p:grpSpPr>
        <p:cxnSp>
          <p:nvCxnSpPr>
            <p:cNvPr id="107" name="Straight Connector 106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/>
            <p:cNvCxnSpPr/>
            <p:nvPr/>
          </p:nvCxnSpPr>
          <p:spPr>
            <a:xfrm>
              <a:off x="630932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/>
            <p:cNvCxnSpPr/>
            <p:nvPr/>
          </p:nvCxnSpPr>
          <p:spPr>
            <a:xfrm flipH="1">
              <a:off x="6309320" y="2627784"/>
              <a:ext cx="504057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Box 109"/>
            <p:cNvSpPr txBox="1"/>
            <p:nvPr/>
          </p:nvSpPr>
          <p:spPr>
            <a:xfrm>
              <a:off x="6381329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pic>
        <p:nvPicPr>
          <p:cNvPr id="6" name="Picture 6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61"/>
          <a:stretch/>
        </p:blipFill>
        <p:spPr bwMode="auto">
          <a:xfrm>
            <a:off x="4840982" y="1654178"/>
            <a:ext cx="1326480" cy="11802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81" name="Group 80"/>
          <p:cNvGrpSpPr/>
          <p:nvPr/>
        </p:nvGrpSpPr>
        <p:grpSpPr>
          <a:xfrm>
            <a:off x="5525616" y="1504482"/>
            <a:ext cx="504057" cy="259206"/>
            <a:chOff x="6309320" y="2483768"/>
            <a:chExt cx="504057" cy="259206"/>
          </a:xfrm>
        </p:grpSpPr>
        <p:cxnSp>
          <p:nvCxnSpPr>
            <p:cNvPr id="82" name="Straight Connector 81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>
              <a:off x="630932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 flipH="1">
              <a:off x="6309320" y="2627784"/>
              <a:ext cx="504057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/>
            <p:cNvSpPr txBox="1"/>
            <p:nvPr/>
          </p:nvSpPr>
          <p:spPr>
            <a:xfrm>
              <a:off x="6381329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pic>
        <p:nvPicPr>
          <p:cNvPr id="7" name="Picture 7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169"/>
          <a:stretch/>
        </p:blipFill>
        <p:spPr bwMode="auto">
          <a:xfrm>
            <a:off x="4723499" y="152014"/>
            <a:ext cx="1316955" cy="11763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079" name="Group 2078"/>
          <p:cNvGrpSpPr/>
          <p:nvPr/>
        </p:nvGrpSpPr>
        <p:grpSpPr>
          <a:xfrm>
            <a:off x="5373216" y="136330"/>
            <a:ext cx="504057" cy="259206"/>
            <a:chOff x="6309320" y="2483768"/>
            <a:chExt cx="504057" cy="259206"/>
          </a:xfrm>
        </p:grpSpPr>
        <p:cxnSp>
          <p:nvCxnSpPr>
            <p:cNvPr id="2075" name="Straight Connector 2074"/>
            <p:cNvCxnSpPr/>
            <p:nvPr/>
          </p:nvCxnSpPr>
          <p:spPr>
            <a:xfrm>
              <a:off x="680714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6309320" y="2627784"/>
              <a:ext cx="0" cy="11519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 flipH="1">
              <a:off x="6309320" y="2627784"/>
              <a:ext cx="504057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8" name="TextBox 2077"/>
            <p:cNvSpPr txBox="1"/>
            <p:nvPr/>
          </p:nvSpPr>
          <p:spPr>
            <a:xfrm>
              <a:off x="6381329" y="2483768"/>
              <a:ext cx="4320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***</a:t>
              </a:r>
              <a:endParaRPr lang="en-GB" sz="1000" b="1" dirty="0"/>
            </a:p>
          </p:txBody>
        </p:sp>
      </p:grpSp>
      <p:sp>
        <p:nvSpPr>
          <p:cNvPr id="57" name="TextBox 56"/>
          <p:cNvSpPr txBox="1"/>
          <p:nvPr/>
        </p:nvSpPr>
        <p:spPr>
          <a:xfrm>
            <a:off x="6181368" y="2107263"/>
            <a:ext cx="5506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Etv3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76672" y="6107863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</a:t>
            </a:r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Combinatorials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76672" y="4451679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</a:t>
            </a:r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Combinatorials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4657214" y="2795495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</a:t>
            </a:r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Combinatorials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4585206" y="1283327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</a:t>
            </a:r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Combinatorials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017254" y="4523687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</a:t>
            </a:r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Combinatorials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013176" y="5923533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</a:t>
            </a:r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Combinatorials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433078" y="5912775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</a:t>
            </a:r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Combinatorials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429000" y="4544623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</a:t>
            </a:r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Combinatorials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492896" y="1539085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</a:t>
            </a:r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Combinatorials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2496974" y="2899197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</a:t>
            </a:r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Combinatorials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908720" y="2866923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</a:t>
            </a:r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Combinatorials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899750" y="1549843"/>
            <a:ext cx="186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Singletons  </a:t>
            </a:r>
            <a:r>
              <a:rPr lang="en-GB" sz="800" dirty="0" err="1" smtClean="0">
                <a:latin typeface="Times New Roman" pitchFamily="18" charset="0"/>
                <a:cs typeface="Times New Roman" pitchFamily="18" charset="0"/>
              </a:rPr>
              <a:t>Combinatorials</a:t>
            </a:r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  Hotspots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5727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52</TotalTime>
  <Words>709</Words>
  <Application>Microsoft Office PowerPoint</Application>
  <PresentationFormat>On-screen Show (4:3)</PresentationFormat>
  <Paragraphs>176</Paragraphs>
  <Slides>7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HI Anagha</dc:creator>
  <cp:lastModifiedBy>JOSHI Anagha</cp:lastModifiedBy>
  <cp:revision>313</cp:revision>
  <dcterms:created xsi:type="dcterms:W3CDTF">2013-04-11T13:14:40Z</dcterms:created>
  <dcterms:modified xsi:type="dcterms:W3CDTF">2014-10-31T10:52:36Z</dcterms:modified>
</cp:coreProperties>
</file>